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23" userDrawn="1">
          <p15:clr>
            <a:srgbClr val="A4A3A4"/>
          </p15:clr>
        </p15:guide>
        <p15:guide id="2" pos="56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54" d="100"/>
          <a:sy n="154" d="100"/>
        </p:scale>
        <p:origin x="174" y="204"/>
      </p:cViewPr>
      <p:guideLst>
        <p:guide orient="horz" pos="2523"/>
        <p:guide pos="56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'gestapelte Balken sum 10'!$O$2</c:f>
              <c:strCache>
                <c:ptCount val="1"/>
                <c:pt idx="0">
                  <c:v> BDE 209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O$3:$O$19</c:f>
              <c:numCache>
                <c:formatCode>0.0</c:formatCode>
                <c:ptCount val="17"/>
                <c:pt idx="0">
                  <c:v>61.858240587528599</c:v>
                </c:pt>
                <c:pt idx="1">
                  <c:v>64.3846794425165</c:v>
                </c:pt>
                <c:pt idx="2">
                  <c:v>92.565428979441549</c:v>
                </c:pt>
                <c:pt idx="3">
                  <c:v>88.311349321988885</c:v>
                </c:pt>
                <c:pt idx="4">
                  <c:v>71.823204419889507</c:v>
                </c:pt>
                <c:pt idx="5">
                  <c:v>87.162585474412424</c:v>
                </c:pt>
                <c:pt idx="6">
                  <c:v>60.108157148570008</c:v>
                </c:pt>
                <c:pt idx="7">
                  <c:v>95.569242206620203</c:v>
                </c:pt>
                <c:pt idx="8">
                  <c:v>69.94793290006389</c:v>
                </c:pt>
                <c:pt idx="9">
                  <c:v>70.769166911452984</c:v>
                </c:pt>
                <c:pt idx="10">
                  <c:v>1.6675263572956949</c:v>
                </c:pt>
                <c:pt idx="11">
                  <c:v>31.022369127116932</c:v>
                </c:pt>
                <c:pt idx="12">
                  <c:v>65.818417080008615</c:v>
                </c:pt>
                <c:pt idx="13">
                  <c:v>83.711158936290047</c:v>
                </c:pt>
                <c:pt idx="14">
                  <c:v>84.571296073262488</c:v>
                </c:pt>
                <c:pt idx="15">
                  <c:v>76.892965056527402</c:v>
                </c:pt>
                <c:pt idx="16">
                  <c:v>78.551290404485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40-45E4-B511-CA565C96353F}"/>
            </c:ext>
          </c:extLst>
        </c:ser>
        <c:ser>
          <c:idx val="1"/>
          <c:order val="1"/>
          <c:tx>
            <c:strRef>
              <c:f>'gestapelte Balken sum 10'!$P$2</c:f>
              <c:strCache>
                <c:ptCount val="1"/>
                <c:pt idx="0">
                  <c:v>BDE 47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P$3:$P$19</c:f>
              <c:numCache>
                <c:formatCode>0.0</c:formatCode>
                <c:ptCount val="17"/>
                <c:pt idx="0">
                  <c:v>12.021181438866231</c:v>
                </c:pt>
                <c:pt idx="1">
                  <c:v>11.673640036316858</c:v>
                </c:pt>
                <c:pt idx="2">
                  <c:v>1.4957907452736583</c:v>
                </c:pt>
                <c:pt idx="3">
                  <c:v>3.3782577688186102</c:v>
                </c:pt>
                <c:pt idx="4">
                  <c:v>4.0554837192899971</c:v>
                </c:pt>
                <c:pt idx="5">
                  <c:v>3.365599103438794</c:v>
                </c:pt>
                <c:pt idx="6">
                  <c:v>14.366300339353435</c:v>
                </c:pt>
                <c:pt idx="7">
                  <c:v>1.335950740503685</c:v>
                </c:pt>
                <c:pt idx="8">
                  <c:v>5.7720775938253128</c:v>
                </c:pt>
                <c:pt idx="9">
                  <c:v>11.125101704173442</c:v>
                </c:pt>
                <c:pt idx="10">
                  <c:v>48.789826390267436</c:v>
                </c:pt>
                <c:pt idx="11">
                  <c:v>19.29129202868625</c:v>
                </c:pt>
                <c:pt idx="12">
                  <c:v>10.380274602832291</c:v>
                </c:pt>
                <c:pt idx="13">
                  <c:v>5.7359592099608978</c:v>
                </c:pt>
                <c:pt idx="14">
                  <c:v>3.8537429284731815</c:v>
                </c:pt>
                <c:pt idx="15">
                  <c:v>6.655266027935661</c:v>
                </c:pt>
                <c:pt idx="16">
                  <c:v>4.97167317403336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40-45E4-B511-CA565C96353F}"/>
            </c:ext>
          </c:extLst>
        </c:ser>
        <c:ser>
          <c:idx val="2"/>
          <c:order val="2"/>
          <c:tx>
            <c:strRef>
              <c:f>'gestapelte Balken sum 10'!$Q$2</c:f>
              <c:strCache>
                <c:ptCount val="1"/>
                <c:pt idx="0">
                  <c:v>BDE 99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Q$3:$Q$19</c:f>
              <c:numCache>
                <c:formatCode>0.0</c:formatCode>
                <c:ptCount val="17"/>
                <c:pt idx="0">
                  <c:v>14.155889670997219</c:v>
                </c:pt>
                <c:pt idx="1">
                  <c:v>13.030152103345616</c:v>
                </c:pt>
                <c:pt idx="2">
                  <c:v>2.2168884971076124</c:v>
                </c:pt>
                <c:pt idx="3">
                  <c:v>3.5417793540904361</c:v>
                </c:pt>
                <c:pt idx="4">
                  <c:v>3.3384271776184327</c:v>
                </c:pt>
                <c:pt idx="5">
                  <c:v>3.5849615006883542</c:v>
                </c:pt>
                <c:pt idx="6">
                  <c:v>16.657473247624051</c:v>
                </c:pt>
                <c:pt idx="7">
                  <c:v>1.0219657419591257</c:v>
                </c:pt>
                <c:pt idx="8">
                  <c:v>13.744835141680115</c:v>
                </c:pt>
                <c:pt idx="9">
                  <c:v>11.126427675606489</c:v>
                </c:pt>
                <c:pt idx="10">
                  <c:v>5.4035106802618165</c:v>
                </c:pt>
                <c:pt idx="11">
                  <c:v>22.972316862542055</c:v>
                </c:pt>
                <c:pt idx="12">
                  <c:v>7.4760980519013724</c:v>
                </c:pt>
                <c:pt idx="13">
                  <c:v>5.1398525987810313</c:v>
                </c:pt>
                <c:pt idx="14">
                  <c:v>4.499213211739467</c:v>
                </c:pt>
                <c:pt idx="15">
                  <c:v>6.2040799206430775</c:v>
                </c:pt>
                <c:pt idx="16">
                  <c:v>6.29960067850035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840-45E4-B511-CA565C96353F}"/>
            </c:ext>
          </c:extLst>
        </c:ser>
        <c:ser>
          <c:idx val="3"/>
          <c:order val="3"/>
          <c:tx>
            <c:strRef>
              <c:f>'gestapelte Balken sum 10'!$R$2</c:f>
              <c:strCache>
                <c:ptCount val="1"/>
                <c:pt idx="0">
                  <c:v>BDE 100</c:v>
                </c:pt>
              </c:strCache>
            </c:strRef>
          </c:tx>
          <c:spPr>
            <a:solidFill>
              <a:schemeClr val="accent1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R$3:$R$19</c:f>
              <c:numCache>
                <c:formatCode>0.0</c:formatCode>
                <c:ptCount val="17"/>
                <c:pt idx="0">
                  <c:v>2.3312136783134352</c:v>
                </c:pt>
                <c:pt idx="1">
                  <c:v>2.4249442729622541</c:v>
                </c:pt>
                <c:pt idx="2">
                  <c:v>0.61462433034118269</c:v>
                </c:pt>
                <c:pt idx="3">
                  <c:v>1.0544794611514312</c:v>
                </c:pt>
                <c:pt idx="4">
                  <c:v>2.7506759139532155</c:v>
                </c:pt>
                <c:pt idx="5">
                  <c:v>0.90161551731638168</c:v>
                </c:pt>
                <c:pt idx="6">
                  <c:v>2.2367144146231754</c:v>
                </c:pt>
                <c:pt idx="7">
                  <c:v>0.25822515129515711</c:v>
                </c:pt>
                <c:pt idx="8">
                  <c:v>2.339198853170954</c:v>
                </c:pt>
                <c:pt idx="9">
                  <c:v>1.5018648305105959</c:v>
                </c:pt>
                <c:pt idx="10">
                  <c:v>19.739214042338109</c:v>
                </c:pt>
                <c:pt idx="11">
                  <c:v>4.7120518224354662</c:v>
                </c:pt>
                <c:pt idx="12">
                  <c:v>2.6525770972611595</c:v>
                </c:pt>
                <c:pt idx="13">
                  <c:v>1.0766057281293726</c:v>
                </c:pt>
                <c:pt idx="14">
                  <c:v>1.1509170191643161</c:v>
                </c:pt>
                <c:pt idx="15">
                  <c:v>1.798050516689969</c:v>
                </c:pt>
                <c:pt idx="16">
                  <c:v>1.25118991543806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840-45E4-B511-CA565C96353F}"/>
            </c:ext>
          </c:extLst>
        </c:ser>
        <c:ser>
          <c:idx val="4"/>
          <c:order val="4"/>
          <c:tx>
            <c:strRef>
              <c:f>'gestapelte Balken sum 10'!$S$2</c:f>
              <c:strCache>
                <c:ptCount val="1"/>
                <c:pt idx="0">
                  <c:v> BDE 183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S$3:$S$19</c:f>
              <c:numCache>
                <c:formatCode>0.0</c:formatCode>
                <c:ptCount val="17"/>
                <c:pt idx="0">
                  <c:v>2.1664420308933763</c:v>
                </c:pt>
                <c:pt idx="1">
                  <c:v>2.1043337560126174</c:v>
                </c:pt>
                <c:pt idx="2">
                  <c:v>0.61462433034118269</c:v>
                </c:pt>
                <c:pt idx="3">
                  <c:v>0.82142913487952773</c:v>
                </c:pt>
                <c:pt idx="4">
                  <c:v>3.0092864699659114</c:v>
                </c:pt>
                <c:pt idx="5">
                  <c:v>1.9228168416776974</c:v>
                </c:pt>
                <c:pt idx="6">
                  <c:v>1.4275166379444668</c:v>
                </c:pt>
                <c:pt idx="7">
                  <c:v>0.79676535164101403</c:v>
                </c:pt>
                <c:pt idx="8">
                  <c:v>2.1864827261396402</c:v>
                </c:pt>
                <c:pt idx="9">
                  <c:v>1.6242204077624149</c:v>
                </c:pt>
                <c:pt idx="10">
                  <c:v>0.13774744526288579</c:v>
                </c:pt>
                <c:pt idx="11">
                  <c:v>10.190003802495548</c:v>
                </c:pt>
                <c:pt idx="12">
                  <c:v>3.9824599238013079</c:v>
                </c:pt>
                <c:pt idx="13">
                  <c:v>1.2396075869855288</c:v>
                </c:pt>
                <c:pt idx="14">
                  <c:v>1.6152233960887958</c:v>
                </c:pt>
                <c:pt idx="15">
                  <c:v>2.3471610341411382</c:v>
                </c:pt>
                <c:pt idx="16">
                  <c:v>1.4140765098183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840-45E4-B511-CA565C96353F}"/>
            </c:ext>
          </c:extLst>
        </c:ser>
        <c:ser>
          <c:idx val="5"/>
          <c:order val="5"/>
          <c:tx>
            <c:strRef>
              <c:f>'gestapelte Balken sum 10'!$T$2</c:f>
              <c:strCache>
                <c:ptCount val="1"/>
                <c:pt idx="0">
                  <c:v>BDE 153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T$3:$T$19</c:f>
              <c:numCache>
                <c:formatCode>0.0</c:formatCode>
                <c:ptCount val="17"/>
                <c:pt idx="0">
                  <c:v>3.0870709180657721</c:v>
                </c:pt>
                <c:pt idx="1">
                  <c:v>2.6964763683607367</c:v>
                </c:pt>
                <c:pt idx="2">
                  <c:v>0.73072003718340617</c:v>
                </c:pt>
                <c:pt idx="3">
                  <c:v>0.72923040405800887</c:v>
                </c:pt>
                <c:pt idx="4">
                  <c:v>2.9152462677794766</c:v>
                </c:pt>
                <c:pt idx="5">
                  <c:v>0.83580416568744853</c:v>
                </c:pt>
                <c:pt idx="6">
                  <c:v>3.236009691703766</c:v>
                </c:pt>
                <c:pt idx="7">
                  <c:v>0.41138530097032955</c:v>
                </c:pt>
                <c:pt idx="8">
                  <c:v>3.9403665998318917</c:v>
                </c:pt>
                <c:pt idx="9">
                  <c:v>1.9711054374355872</c:v>
                </c:pt>
                <c:pt idx="10">
                  <c:v>3.0664123353446744</c:v>
                </c:pt>
                <c:pt idx="11">
                  <c:v>7.2161428123204159</c:v>
                </c:pt>
                <c:pt idx="12">
                  <c:v>2.3290920854000428</c:v>
                </c:pt>
                <c:pt idx="13">
                  <c:v>1.0212804641051407</c:v>
                </c:pt>
                <c:pt idx="14">
                  <c:v>1.3901051527314725</c:v>
                </c:pt>
                <c:pt idx="15">
                  <c:v>1.7646352791743418</c:v>
                </c:pt>
                <c:pt idx="16">
                  <c:v>1.38618034328621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840-45E4-B511-CA565C96353F}"/>
            </c:ext>
          </c:extLst>
        </c:ser>
        <c:ser>
          <c:idx val="6"/>
          <c:order val="6"/>
          <c:tx>
            <c:strRef>
              <c:f>'gestapelte Balken sum 10'!$U$2</c:f>
              <c:strCache>
                <c:ptCount val="1"/>
                <c:pt idx="0">
                  <c:v>BDE 154</c:v>
                </c:pt>
              </c:strCache>
            </c:strRef>
          </c:tx>
          <c:spPr>
            <a:solidFill>
              <a:schemeClr val="bg2">
                <a:lumMod val="90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U$3:$U$19</c:f>
              <c:numCache>
                <c:formatCode>0.0</c:formatCode>
                <c:ptCount val="17"/>
                <c:pt idx="0">
                  <c:v>1.8063854680125051</c:v>
                </c:pt>
                <c:pt idx="1">
                  <c:v>1.6336298330164158</c:v>
                </c:pt>
                <c:pt idx="2">
                  <c:v>0.49852862349895932</c:v>
                </c:pt>
                <c:pt idx="3">
                  <c:v>0.65710115424467064</c:v>
                </c:pt>
                <c:pt idx="4">
                  <c:v>3.7145879863641715</c:v>
                </c:pt>
                <c:pt idx="5">
                  <c:v>0.71515002103440473</c:v>
                </c:pt>
                <c:pt idx="6">
                  <c:v>0.95258248554541491</c:v>
                </c:pt>
                <c:pt idx="7">
                  <c:v>0.17910854383353514</c:v>
                </c:pt>
                <c:pt idx="8">
                  <c:v>1.2797622408334421</c:v>
                </c:pt>
                <c:pt idx="9">
                  <c:v>0.79824762950379013</c:v>
                </c:pt>
                <c:pt idx="10">
                  <c:v>8.7244253102168621</c:v>
                </c:pt>
                <c:pt idx="11">
                  <c:v>3.2503780818831505</c:v>
                </c:pt>
                <c:pt idx="12">
                  <c:v>1.8402702896987995</c:v>
                </c:pt>
                <c:pt idx="13">
                  <c:v>0.65505408395810327</c:v>
                </c:pt>
                <c:pt idx="14">
                  <c:v>0.89343802832437746</c:v>
                </c:pt>
                <c:pt idx="15">
                  <c:v>1.3488869249114586</c:v>
                </c:pt>
                <c:pt idx="16">
                  <c:v>0.832545312520548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840-45E4-B511-CA565C96353F}"/>
            </c:ext>
          </c:extLst>
        </c:ser>
        <c:ser>
          <c:idx val="7"/>
          <c:order val="7"/>
          <c:tx>
            <c:strRef>
              <c:f>'gestapelte Balken sum 10'!$V$2</c:f>
              <c:strCache>
                <c:ptCount val="1"/>
                <c:pt idx="0">
                  <c:v>BDE 49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V$3:$V$19</c:f>
              <c:numCache>
                <c:formatCode>0.0</c:formatCode>
                <c:ptCount val="17"/>
                <c:pt idx="0">
                  <c:v>0.8578587357742784</c:v>
                </c:pt>
                <c:pt idx="1">
                  <c:v>0.81126167683870287</c:v>
                </c:pt>
                <c:pt idx="2">
                  <c:v>0.38243291665673596</c:v>
                </c:pt>
                <c:pt idx="3">
                  <c:v>0.50212446692281432</c:v>
                </c:pt>
                <c:pt idx="4">
                  <c:v>2.7506759139532155</c:v>
                </c:pt>
                <c:pt idx="5">
                  <c:v>0.49139142549603282</c:v>
                </c:pt>
                <c:pt idx="6">
                  <c:v>0.30702686004570573</c:v>
                </c:pt>
                <c:pt idx="7">
                  <c:v>0.13301529349361818</c:v>
                </c:pt>
                <c:pt idx="8">
                  <c:v>0.26311464815158125</c:v>
                </c:pt>
                <c:pt idx="9">
                  <c:v>0.35401994246284491</c:v>
                </c:pt>
                <c:pt idx="10">
                  <c:v>10.07196849010025</c:v>
                </c:pt>
                <c:pt idx="11">
                  <c:v>0.32304016890200521</c:v>
                </c:pt>
                <c:pt idx="12">
                  <c:v>1.8402702896987995</c:v>
                </c:pt>
                <c:pt idx="13">
                  <c:v>0.39931801166966224</c:v>
                </c:pt>
                <c:pt idx="14">
                  <c:v>0.7034945104916358</c:v>
                </c:pt>
                <c:pt idx="15">
                  <c:v>0.94090702937843163</c:v>
                </c:pt>
                <c:pt idx="16">
                  <c:v>0.587363237752134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840-45E4-B511-CA565C96353F}"/>
            </c:ext>
          </c:extLst>
        </c:ser>
        <c:ser>
          <c:idx val="8"/>
          <c:order val="8"/>
          <c:tx>
            <c:strRef>
              <c:f>'gestapelte Balken sum 10'!$W$2</c:f>
              <c:strCache>
                <c:ptCount val="1"/>
                <c:pt idx="0">
                  <c:v>BDE 138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W$3:$W$19</c:f>
              <c:numCache>
                <c:formatCode>0.0</c:formatCode>
                <c:ptCount val="17"/>
                <c:pt idx="0">
                  <c:v>0.8578587357742784</c:v>
                </c:pt>
                <c:pt idx="1">
                  <c:v>0.63261950991038418</c:v>
                </c:pt>
                <c:pt idx="2">
                  <c:v>0.38243291665673596</c:v>
                </c:pt>
                <c:pt idx="3">
                  <c:v>0.50212446692281432</c:v>
                </c:pt>
                <c:pt idx="4">
                  <c:v>2.7506759139532155</c:v>
                </c:pt>
                <c:pt idx="5">
                  <c:v>0.49139142549603282</c:v>
                </c:pt>
                <c:pt idx="6">
                  <c:v>0.30702686004570573</c:v>
                </c:pt>
                <c:pt idx="7">
                  <c:v>0.16811167700116922</c:v>
                </c:pt>
                <c:pt idx="8">
                  <c:v>0.26311464815158125</c:v>
                </c:pt>
                <c:pt idx="9">
                  <c:v>0.36492273054593977</c:v>
                </c:pt>
                <c:pt idx="10" formatCode="0.00">
                  <c:v>2.0600570140344995E-2</c:v>
                </c:pt>
                <c:pt idx="11">
                  <c:v>0.60218624330348125</c:v>
                </c:pt>
                <c:pt idx="12">
                  <c:v>1.8402702896987995</c:v>
                </c:pt>
                <c:pt idx="13">
                  <c:v>0.42026988265232973</c:v>
                </c:pt>
                <c:pt idx="14">
                  <c:v>0.63033108140050575</c:v>
                </c:pt>
                <c:pt idx="15">
                  <c:v>0.94090702937843163</c:v>
                </c:pt>
                <c:pt idx="16">
                  <c:v>4.2370291176865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840-45E4-B511-CA565C96353F}"/>
            </c:ext>
          </c:extLst>
        </c:ser>
        <c:ser>
          <c:idx val="9"/>
          <c:order val="9"/>
          <c:tx>
            <c:strRef>
              <c:f>'gestapelte Balken sum 10'!$X$2</c:f>
              <c:strCache>
                <c:ptCount val="1"/>
                <c:pt idx="0">
                  <c:v>BDE 28</c:v>
                </c:pt>
              </c:strCache>
            </c:strRef>
          </c:tx>
          <c:spPr>
            <a:solidFill>
              <a:schemeClr val="bg2">
                <a:lumMod val="25000"/>
              </a:schemeClr>
            </a:solidFill>
            <a:ln>
              <a:solidFill>
                <a:schemeClr val="tx1"/>
              </a:solidFill>
            </a:ln>
          </c:spPr>
          <c:invertIfNegative val="0"/>
          <c:dLbls>
            <c:delete val="1"/>
          </c:dLbls>
          <c:cat>
            <c:strRef>
              <c:f>'gestapelte Balken sum 10'!$N$3:$N$19</c:f>
              <c:strCache>
                <c:ptCount val="17"/>
                <c:pt idx="0">
                  <c:v>Seasoning, sauces and condiments</c:v>
                </c:pt>
                <c:pt idx="1">
                  <c:v>Composite dishes</c:v>
                </c:pt>
                <c:pt idx="2">
                  <c:v>Products for non-standard diets and food imitates</c:v>
                </c:pt>
                <c:pt idx="3">
                  <c:v>Food products for infants and toddlers</c:v>
                </c:pt>
                <c:pt idx="4">
                  <c:v>Alcoholic beverages</c:v>
                </c:pt>
                <c:pt idx="5">
                  <c:v>Coffee, cocoa, tea and infusions</c:v>
                </c:pt>
                <c:pt idx="6">
                  <c:v>Animal and vegetable fats and oils</c:v>
                </c:pt>
                <c:pt idx="7">
                  <c:v>Sugar, confectionery and water-based sweet desserts</c:v>
                </c:pt>
                <c:pt idx="8">
                  <c:v>Eggs and egg products</c:v>
                </c:pt>
                <c:pt idx="9">
                  <c:v>Milk and dairy products</c:v>
                </c:pt>
                <c:pt idx="10">
                  <c:v>Fish, seafood and invertebrates</c:v>
                </c:pt>
                <c:pt idx="11">
                  <c:v>Meat and meat products</c:v>
                </c:pt>
                <c:pt idx="12">
                  <c:v>Fruit and fruit products</c:v>
                </c:pt>
                <c:pt idx="13">
                  <c:v>Legumes, nuts, oilseeds and spices</c:v>
                </c:pt>
                <c:pt idx="14">
                  <c:v>Starchy roots or tubers and products thereof</c:v>
                </c:pt>
                <c:pt idx="15">
                  <c:v>Vegetables and vegetable products</c:v>
                </c:pt>
                <c:pt idx="16">
                  <c:v>Grains and grain-based products</c:v>
                </c:pt>
              </c:strCache>
            </c:strRef>
          </c:cat>
          <c:val>
            <c:numRef>
              <c:f>'gestapelte Balken sum 10'!$X$3:$X$19</c:f>
              <c:numCache>
                <c:formatCode>0.0</c:formatCode>
                <c:ptCount val="17"/>
                <c:pt idx="0">
                  <c:v>0.8578587357742784</c:v>
                </c:pt>
                <c:pt idx="1">
                  <c:v>0.60826300071993367</c:v>
                </c:pt>
                <c:pt idx="2">
                  <c:v>0.49852862349895932</c:v>
                </c:pt>
                <c:pt idx="3">
                  <c:v>0.50212446692281432</c:v>
                </c:pt>
                <c:pt idx="4">
                  <c:v>2.8917362172328671</c:v>
                </c:pt>
                <c:pt idx="5">
                  <c:v>0.52868452475242811</c:v>
                </c:pt>
                <c:pt idx="6">
                  <c:v>0.40119231454425969</c:v>
                </c:pt>
                <c:pt idx="7">
                  <c:v>0.12622999268215837</c:v>
                </c:pt>
                <c:pt idx="8">
                  <c:v>0.26311464815158125</c:v>
                </c:pt>
                <c:pt idx="9">
                  <c:v>0.36492273054593977</c:v>
                </c:pt>
                <c:pt idx="10">
                  <c:v>2.3787683787719214</c:v>
                </c:pt>
                <c:pt idx="11">
                  <c:v>0.42021905031469231</c:v>
                </c:pt>
                <c:pt idx="12">
                  <c:v>1.8402702896987995</c:v>
                </c:pt>
                <c:pt idx="13">
                  <c:v>0.60089349746790788</c:v>
                </c:pt>
                <c:pt idx="14">
                  <c:v>0.69223859832376955</c:v>
                </c:pt>
                <c:pt idx="15">
                  <c:v>1.1071411812201177</c:v>
                </c:pt>
                <c:pt idx="16">
                  <c:v>0.469051306478715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840-45E4-B511-CA565C96353F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50"/>
        <c:overlap val="100"/>
        <c:axId val="450736488"/>
        <c:axId val="450736816"/>
      </c:barChart>
      <c:catAx>
        <c:axId val="4507364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450736816"/>
        <c:crosses val="autoZero"/>
        <c:auto val="1"/>
        <c:lblAlgn val="ctr"/>
        <c:lblOffset val="100"/>
        <c:noMultiLvlLbl val="0"/>
      </c:catAx>
      <c:valAx>
        <c:axId val="450736816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dirty="0" err="1">
                    <a:solidFill>
                      <a:schemeClr val="tx1"/>
                    </a:solidFill>
                  </a:rPr>
                  <a:t>Contribution</a:t>
                </a:r>
                <a:r>
                  <a:rPr lang="de-DE" dirty="0">
                    <a:solidFill>
                      <a:schemeClr val="tx1"/>
                    </a:solidFill>
                  </a:rPr>
                  <a:t> </a:t>
                </a:r>
                <a:r>
                  <a:rPr lang="de-DE" dirty="0" err="1">
                    <a:solidFill>
                      <a:schemeClr val="tx1"/>
                    </a:solidFill>
                  </a:rPr>
                  <a:t>of</a:t>
                </a:r>
                <a:r>
                  <a:rPr lang="de-DE" dirty="0">
                    <a:solidFill>
                      <a:schemeClr val="tx1"/>
                    </a:solidFill>
                  </a:rPr>
                  <a:t> </a:t>
                </a:r>
                <a:r>
                  <a:rPr lang="de-DE" dirty="0" err="1">
                    <a:solidFill>
                      <a:schemeClr val="tx1"/>
                    </a:solidFill>
                  </a:rPr>
                  <a:t>single</a:t>
                </a:r>
                <a:r>
                  <a:rPr lang="de-DE" dirty="0">
                    <a:solidFill>
                      <a:schemeClr val="tx1"/>
                    </a:solidFill>
                  </a:rPr>
                  <a:t> </a:t>
                </a:r>
                <a:r>
                  <a:rPr lang="de-DE" dirty="0" err="1">
                    <a:solidFill>
                      <a:schemeClr val="tx1"/>
                    </a:solidFill>
                  </a:rPr>
                  <a:t>congeners</a:t>
                </a:r>
                <a:r>
                  <a:rPr lang="de-DE" dirty="0">
                    <a:solidFill>
                      <a:schemeClr val="tx1"/>
                    </a:solidFill>
                  </a:rPr>
                  <a:t> </a:t>
                </a:r>
                <a:r>
                  <a:rPr lang="de-DE" dirty="0" err="1">
                    <a:solidFill>
                      <a:schemeClr val="tx1"/>
                    </a:solidFill>
                  </a:rPr>
                  <a:t>to</a:t>
                </a:r>
                <a:r>
                  <a:rPr lang="de-DE" dirty="0">
                    <a:solidFill>
                      <a:schemeClr val="tx1"/>
                    </a:solidFill>
                  </a:rPr>
                  <a:t> </a:t>
                </a:r>
                <a:r>
                  <a:rPr lang="de-DE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∑10 </a:t>
                </a:r>
                <a:r>
                  <a:rPr lang="de-DE" dirty="0">
                    <a:solidFill>
                      <a:schemeClr val="tx1"/>
                    </a:solidFill>
                  </a:rPr>
                  <a:t>PBDEs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450736488"/>
        <c:crosses val="autoZero"/>
        <c:crossBetween val="between"/>
        <c:minorUnit val="5"/>
      </c:valAx>
    </c:plotArea>
    <c:legend>
      <c:legendPos val="b"/>
      <c:layout>
        <c:manualLayout>
          <c:xMode val="edge"/>
          <c:yMode val="edge"/>
          <c:x val="5.978101704319185E-3"/>
          <c:y val="0.89195163586875292"/>
          <c:w val="0.97776948818388676"/>
          <c:h val="0.10804836413124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Highest 209'!$I$1</c:f>
              <c:strCache>
                <c:ptCount val="1"/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numFmt formatCode="#,##0.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0-7C81-4ED9-AF03-A79A396A5020}"/>
                </c:ext>
              </c:extLst>
            </c:dLbl>
            <c:dLbl>
              <c:idx val="1"/>
              <c:numFmt formatCode="#,##0.0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de-DE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1-7C81-4ED9-AF03-A79A396A5020}"/>
                </c:ext>
              </c:extLst>
            </c:dLbl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de-DE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Highest 209'!$H$2:$H$16</c:f>
              <c:strCache>
                <c:ptCount val="15"/>
                <c:pt idx="0">
                  <c:v>Fries/chips</c:v>
                </c:pt>
                <c:pt idx="1">
                  <c:v>Gingerbread and gingerbread products</c:v>
                </c:pt>
                <c:pt idx="2">
                  <c:v>Sunflower seed oil</c:v>
                </c:pt>
                <c:pt idx="3">
                  <c:v>Chocolate-coated marshmallow treats</c:v>
                </c:pt>
                <c:pt idx="4">
                  <c:v>Chocolate bar</c:v>
                </c:pt>
                <c:pt idx="5">
                  <c:v>Rice cracker, puffed</c:v>
                </c:pt>
                <c:pt idx="6">
                  <c:v>Vegetarian sausage</c:v>
                </c:pt>
                <c:pt idx="7">
                  <c:v>Cocoa powder</c:v>
                </c:pt>
                <c:pt idx="8">
                  <c:v>Biscuits and rusks for infants and toddlers</c:v>
                </c:pt>
                <c:pt idx="9">
                  <c:v>Milk chocolate</c:v>
                </c:pt>
                <c:pt idx="10">
                  <c:v>Pralines</c:v>
                </c:pt>
                <c:pt idx="11">
                  <c:v>Filled chocolate</c:v>
                </c:pt>
                <c:pt idx="12">
                  <c:v>Spices</c:v>
                </c:pt>
                <c:pt idx="13">
                  <c:v>Dark chocolate</c:v>
                </c:pt>
                <c:pt idx="14">
                  <c:v>Ice cream, milk-based</c:v>
                </c:pt>
              </c:strCache>
            </c:strRef>
          </c:cat>
          <c:val>
            <c:numRef>
              <c:f>'Highest 209'!$I$2:$I$16</c:f>
              <c:numCache>
                <c:formatCode>0.00</c:formatCode>
                <c:ptCount val="15"/>
                <c:pt idx="0">
                  <c:v>86.7</c:v>
                </c:pt>
                <c:pt idx="1">
                  <c:v>97</c:v>
                </c:pt>
                <c:pt idx="2">
                  <c:v>99.825000000000003</c:v>
                </c:pt>
                <c:pt idx="3">
                  <c:v>126</c:v>
                </c:pt>
                <c:pt idx="4">
                  <c:v>142</c:v>
                </c:pt>
                <c:pt idx="5">
                  <c:v>143.08333333333331</c:v>
                </c:pt>
                <c:pt idx="6">
                  <c:v>150</c:v>
                </c:pt>
                <c:pt idx="7">
                  <c:v>155.92311999999998</c:v>
                </c:pt>
                <c:pt idx="8">
                  <c:v>174.2</c:v>
                </c:pt>
                <c:pt idx="9">
                  <c:v>190.76249999999999</c:v>
                </c:pt>
                <c:pt idx="10">
                  <c:v>236.36699999999999</c:v>
                </c:pt>
                <c:pt idx="11">
                  <c:v>244</c:v>
                </c:pt>
                <c:pt idx="12">
                  <c:v>245.5</c:v>
                </c:pt>
                <c:pt idx="13">
                  <c:v>306.76</c:v>
                </c:pt>
                <c:pt idx="14">
                  <c:v>5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C81-4ED9-AF03-A79A396A50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850661744"/>
        <c:axId val="850662072"/>
      </c:barChart>
      <c:catAx>
        <c:axId val="85066174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850662072"/>
        <c:crosses val="autoZero"/>
        <c:auto val="1"/>
        <c:lblAlgn val="ctr"/>
        <c:lblOffset val="100"/>
        <c:noMultiLvlLbl val="0"/>
      </c:catAx>
      <c:valAx>
        <c:axId val="850662072"/>
        <c:scaling>
          <c:orientation val="minMax"/>
          <c:max val="6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sz="9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an</a:t>
                </a:r>
                <a:r>
                  <a:rPr lang="de-DE" sz="9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UB </a:t>
                </a:r>
                <a:r>
                  <a:rPr lang="de-DE" sz="9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evels</a:t>
                </a:r>
                <a:r>
                  <a:rPr lang="de-DE" sz="9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BDE-209 (</a:t>
                </a:r>
                <a:r>
                  <a:rPr lang="de-DE" sz="9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g</a:t>
                </a:r>
                <a:r>
                  <a:rPr lang="de-DE" sz="9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g </a:t>
                </a:r>
                <a:r>
                  <a:rPr lang="de-DE" sz="9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t</a:t>
                </a:r>
                <a:r>
                  <a:rPr lang="de-DE" sz="9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9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ight</a:t>
                </a:r>
                <a:r>
                  <a:rPr lang="de-DE" sz="9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)</a:t>
                </a:r>
                <a:endParaRPr lang="de-DE" sz="9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#,##0" sourceLinked="0"/>
        <c:majorTickMark val="out"/>
        <c:minorTickMark val="out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de-DE"/>
          </a:p>
        </c:txPr>
        <c:crossAx val="850661744"/>
        <c:crosses val="autoZero"/>
        <c:crossBetween val="between"/>
        <c:majorUnit val="100"/>
        <c:minorUnit val="50"/>
      </c:valAx>
    </c:plotArea>
    <c:plotVisOnly val="1"/>
    <c:dispBlanksAs val="gap"/>
    <c:showDLblsOverMax val="0"/>
  </c:chart>
  <c:txPr>
    <a:bodyPr/>
    <a:lstStyle/>
    <a:p>
      <a:pPr>
        <a:defRPr/>
      </a:pPr>
      <a:endParaRPr lang="de-DE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70483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4559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2261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7711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118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4905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7693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0669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920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76964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8802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FE8DA-117F-4E87-8A4F-C13187DA2484}" type="datetimeFigureOut">
              <a:rPr lang="de-DE" smtClean="0"/>
              <a:t>11.12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ED348-3815-41BF-8F64-0ED7E8EAD13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828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0379833"/>
              </p:ext>
            </p:extLst>
          </p:nvPr>
        </p:nvGraphicFramePr>
        <p:xfrm>
          <a:off x="407935" y="375951"/>
          <a:ext cx="6332491" cy="3940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hteck 2"/>
          <p:cNvSpPr/>
          <p:nvPr/>
        </p:nvSpPr>
        <p:spPr>
          <a:xfrm>
            <a:off x="326852" y="4380419"/>
            <a:ext cx="1186514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: (A) Mean upper bound relative contribution of ten selected PBDEs across the 17 main food groups (300 MEAL foods). (B) BDE-209 in the 15 MEAL foods exhibiting the highest upper bound (UB) level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0551320"/>
              </p:ext>
            </p:extLst>
          </p:nvPr>
        </p:nvGraphicFramePr>
        <p:xfrm>
          <a:off x="7157326" y="744470"/>
          <a:ext cx="5034674" cy="29580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278426" y="312172"/>
            <a:ext cx="496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6914602" y="312171"/>
            <a:ext cx="49638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65523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Breitbild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Bundesinstitut für Risikobewertu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au Dr. Mandy Stadion</dc:creator>
  <cp:lastModifiedBy>Frau Dr. Mandy Stadion</cp:lastModifiedBy>
  <cp:revision>19</cp:revision>
  <cp:lastPrinted>2023-04-04T11:12:19Z</cp:lastPrinted>
  <dcterms:created xsi:type="dcterms:W3CDTF">2023-03-03T09:02:56Z</dcterms:created>
  <dcterms:modified xsi:type="dcterms:W3CDTF">2023-12-11T14:36:33Z</dcterms:modified>
</cp:coreProperties>
</file>